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6858000" cy="9906000" type="A4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2693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62221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01989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90277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5308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14175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49181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8027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18737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652441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51285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63520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C33121-4824-4F60-A801-00EE80C78FED}" type="datetimeFigureOut">
              <a:rPr lang="hu-HU" smtClean="0"/>
              <a:t>2021. 10. 1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B6EFA7-0B1A-41FB-86E6-7E6BD67656B1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94602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tiff"/><Relationship Id="rId4" Type="http://schemas.openxmlformats.org/officeDocument/2006/relationships/image" Target="../media/image1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GB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br>
              <a:rPr lang="hu-HU" sz="3200" dirty="0">
                <a:latin typeface="Arial" panose="020B0604020202020204" pitchFamily="34" charset="0"/>
                <a:cs typeface="Arial" panose="020B0604020202020204" pitchFamily="34" charset="0"/>
              </a:rPr>
            </a:br>
            <a:br>
              <a:rPr lang="hu-HU" sz="32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GB" sz="3200" b="1" dirty="0">
                <a:latin typeface="Arial" panose="020B0604020202020204" pitchFamily="34" charset="0"/>
                <a:cs typeface="Arial" panose="020B0604020202020204" pitchFamily="34" charset="0"/>
              </a:rPr>
              <a:t>Genome comparisons of the fission yeasts reveal ancient collinear loci maintained by natural selection</a:t>
            </a:r>
            <a:endParaRPr lang="hu-HU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857250" y="5444244"/>
            <a:ext cx="5143500" cy="2391656"/>
          </a:xfrm>
        </p:spPr>
        <p:txBody>
          <a:bodyPr>
            <a:normAutofit/>
          </a:bodyPr>
          <a:lstStyle/>
          <a:p>
            <a:pPr algn="l"/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Lajos 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500" dirty="0" err="1">
                <a:latin typeface="Arial" panose="020B0604020202020204" pitchFamily="34" charset="0"/>
                <a:cs typeface="Arial" panose="020B0604020202020204" pitchFamily="34" charset="0"/>
              </a:rPr>
              <a:t>cs-Szab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5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, L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500" dirty="0" err="1">
                <a:latin typeface="Arial" panose="020B0604020202020204" pitchFamily="34" charset="0"/>
                <a:cs typeface="Arial" panose="020B0604020202020204" pitchFamily="34" charset="0"/>
              </a:rPr>
              <a:t>szl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 Attila Papp, Matthias </a:t>
            </a:r>
            <a:r>
              <a:rPr lang="en-GB" sz="1500" dirty="0" err="1">
                <a:latin typeface="Arial" panose="020B0604020202020204" pitchFamily="34" charset="0"/>
                <a:cs typeface="Arial" panose="020B0604020202020204" pitchFamily="34" charset="0"/>
              </a:rPr>
              <a:t>Sipiczki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 Ida </a:t>
            </a:r>
            <a:r>
              <a:rPr lang="en-GB" sz="1500" dirty="0" err="1">
                <a:latin typeface="Arial" panose="020B0604020202020204" pitchFamily="34" charset="0"/>
                <a:cs typeface="Arial" panose="020B0604020202020204" pitchFamily="34" charset="0"/>
              </a:rPr>
              <a:t>Mikl</a:t>
            </a:r>
            <a:r>
              <a:rPr lang="hu-HU" sz="15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5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hu-HU" sz="15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Department of Genetics and Applied Microbiology, Faculty of Science and Technology, University of Debrecen, 4032 Debrecen, Hungary</a:t>
            </a:r>
            <a:endParaRPr lang="hu-HU" sz="15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GB" sz="15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GB" sz="1500" dirty="0">
                <a:latin typeface="Arial" panose="020B0604020202020204" pitchFamily="34" charset="0"/>
                <a:cs typeface="Arial" panose="020B0604020202020204" pitchFamily="34" charset="0"/>
              </a:rPr>
              <a:t> Correspondence: acs-szabo.lajos@science.unideb.hu; miklos.ida@science.unideb.hu</a:t>
            </a:r>
            <a:endParaRPr lang="hu-HU" sz="15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hu-HU" dirty="0">
              <a:effectLst/>
            </a:endParaRPr>
          </a:p>
          <a:p>
            <a:endParaRPr lang="hu-HU" dirty="0"/>
          </a:p>
        </p:txBody>
      </p:sp>
    </p:spTree>
    <p:extLst>
      <p:ext uri="{BB962C8B-B14F-4D97-AF65-F5344CB8AC3E}">
        <p14:creationId xmlns:p14="http://schemas.microsoft.com/office/powerpoint/2010/main" val="20998276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1.</a:t>
            </a:r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" y="977428"/>
            <a:ext cx="6720840" cy="2011107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" y="3450271"/>
            <a:ext cx="6720840" cy="2011107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" y="5923114"/>
            <a:ext cx="6720840" cy="2011107"/>
          </a:xfrm>
          <a:prstGeom prst="rect">
            <a:avLst/>
          </a:prstGeom>
        </p:spPr>
      </p:pic>
      <p:sp>
        <p:nvSpPr>
          <p:cNvPr id="6" name="Szövegdoboz 5"/>
          <p:cNvSpPr txBox="1"/>
          <p:nvPr/>
        </p:nvSpPr>
        <p:spPr>
          <a:xfrm>
            <a:off x="2980044" y="700428"/>
            <a:ext cx="999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Szövegdoboz 6"/>
          <p:cNvSpPr txBox="1"/>
          <p:nvPr/>
        </p:nvSpPr>
        <p:spPr>
          <a:xfrm>
            <a:off x="2980042" y="5622442"/>
            <a:ext cx="999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Szövegdoboz 7"/>
          <p:cNvSpPr txBox="1"/>
          <p:nvPr/>
        </p:nvSpPr>
        <p:spPr>
          <a:xfrm>
            <a:off x="2980043" y="3168076"/>
            <a:ext cx="999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2954517" y="7686597"/>
            <a:ext cx="1041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ryophil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2924060" y="5163987"/>
            <a:ext cx="1101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ctospor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3065125" y="2692567"/>
            <a:ext cx="8250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ombe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60961" y="673435"/>
            <a:ext cx="289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Szövegdoboz 12"/>
          <p:cNvSpPr txBox="1"/>
          <p:nvPr/>
        </p:nvSpPr>
        <p:spPr>
          <a:xfrm>
            <a:off x="60958" y="3149599"/>
            <a:ext cx="289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Szövegdoboz 13"/>
          <p:cNvSpPr txBox="1"/>
          <p:nvPr/>
        </p:nvSpPr>
        <p:spPr>
          <a:xfrm>
            <a:off x="60961" y="5634278"/>
            <a:ext cx="289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Szövegdoboz 14"/>
          <p:cNvSpPr txBox="1"/>
          <p:nvPr/>
        </p:nvSpPr>
        <p:spPr>
          <a:xfrm>
            <a:off x="147634" y="8267700"/>
            <a:ext cx="658336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airwise whole genome alignments of the fission yeast species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eated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the Mauve aligner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airwise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b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airwise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ospor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airwise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yophil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urful rectangles indicate locally collinear blocks (LCBs) between the genomes.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the reference genome in every alignments. The alignments show conserved, but highly rearranged genome structures.</a:t>
            </a:r>
          </a:p>
        </p:txBody>
      </p:sp>
    </p:spTree>
    <p:extLst>
      <p:ext uri="{BB962C8B-B14F-4D97-AF65-F5344CB8AC3E}">
        <p14:creationId xmlns:p14="http://schemas.microsoft.com/office/powerpoint/2010/main" val="33712602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2.</a:t>
            </a:r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1800" y="673100"/>
            <a:ext cx="6197600" cy="3417074"/>
          </a:xfrm>
          <a:prstGeom prst="rect">
            <a:avLst/>
          </a:prstGeom>
        </p:spPr>
      </p:pic>
      <p:sp>
        <p:nvSpPr>
          <p:cNvPr id="4" name="Szövegdoboz 3"/>
          <p:cNvSpPr txBox="1"/>
          <p:nvPr/>
        </p:nvSpPr>
        <p:spPr>
          <a:xfrm>
            <a:off x="4025737" y="927060"/>
            <a:ext cx="24181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eated-measures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 ANOVA test</a:t>
            </a:r>
          </a:p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 = 0.1988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Szövegdoboz 4"/>
          <p:cNvSpPr txBox="1"/>
          <p:nvPr/>
        </p:nvSpPr>
        <p:spPr>
          <a:xfrm>
            <a:off x="147634" y="8267700"/>
            <a:ext cx="658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evaluation of the normalised data of amino acid differences, pairwise LCBs, pairwise MCDs and multiple MCDs. The data indicated that there were no significant discrepancies among the species pair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-429012" y="2243137"/>
            <a:ext cx="1444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Normalised values</a:t>
            </a:r>
          </a:p>
        </p:txBody>
      </p:sp>
    </p:spTree>
    <p:extLst>
      <p:ext uri="{BB962C8B-B14F-4D97-AF65-F5344CB8AC3E}">
        <p14:creationId xmlns:p14="http://schemas.microsoft.com/office/powerpoint/2010/main" val="14188876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3.</a:t>
            </a:r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01" y="806967"/>
            <a:ext cx="2951106" cy="2951106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678" y="806967"/>
            <a:ext cx="3291840" cy="2951106"/>
          </a:xfrm>
          <a:prstGeom prst="rect">
            <a:avLst/>
          </a:prstGeom>
        </p:spPr>
      </p:pic>
      <p:pic>
        <p:nvPicPr>
          <p:cNvPr id="5" name="Kép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01" y="4304101"/>
            <a:ext cx="2951106" cy="2852735"/>
          </a:xfrm>
          <a:prstGeom prst="rect">
            <a:avLst/>
          </a:prstGeom>
        </p:spPr>
      </p:pic>
      <p:pic>
        <p:nvPicPr>
          <p:cNvPr id="6" name="Kép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2679" y="4304101"/>
            <a:ext cx="2905406" cy="2852735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77786" y="527908"/>
            <a:ext cx="285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Szövegdoboz 7"/>
          <p:cNvSpPr txBox="1"/>
          <p:nvPr/>
        </p:nvSpPr>
        <p:spPr>
          <a:xfrm>
            <a:off x="3403601" y="4010282"/>
            <a:ext cx="285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" name="Szövegdoboz 8"/>
          <p:cNvSpPr txBox="1"/>
          <p:nvPr/>
        </p:nvSpPr>
        <p:spPr>
          <a:xfrm>
            <a:off x="3403601" y="527908"/>
            <a:ext cx="285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Szövegdoboz 9"/>
          <p:cNvSpPr txBox="1"/>
          <p:nvPr/>
        </p:nvSpPr>
        <p:spPr>
          <a:xfrm>
            <a:off x="79375" y="4010283"/>
            <a:ext cx="285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Szövegdoboz 10"/>
          <p:cNvSpPr txBox="1"/>
          <p:nvPr/>
        </p:nvSpPr>
        <p:spPr>
          <a:xfrm>
            <a:off x="879341" y="3681026"/>
            <a:ext cx="9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 rot="16200000">
            <a:off x="2643194" y="5655009"/>
            <a:ext cx="9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 rot="16200000">
            <a:off x="6037696" y="5655009"/>
            <a:ext cx="9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Szövegdoboz 13"/>
          <p:cNvSpPr txBox="1"/>
          <p:nvPr/>
        </p:nvSpPr>
        <p:spPr>
          <a:xfrm rot="16200000">
            <a:off x="6225795" y="2208675"/>
            <a:ext cx="9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Szövegdoboz 14"/>
          <p:cNvSpPr txBox="1"/>
          <p:nvPr/>
        </p:nvSpPr>
        <p:spPr>
          <a:xfrm rot="16200000">
            <a:off x="2638045" y="2213509"/>
            <a:ext cx="987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4711690" y="3681026"/>
            <a:ext cx="815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ombe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Szövegdoboz 16"/>
          <p:cNvSpPr txBox="1"/>
          <p:nvPr/>
        </p:nvSpPr>
        <p:spPr>
          <a:xfrm>
            <a:off x="4401522" y="7112000"/>
            <a:ext cx="1029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ryophil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Szövegdoboz 17"/>
          <p:cNvSpPr txBox="1"/>
          <p:nvPr/>
        </p:nvSpPr>
        <p:spPr>
          <a:xfrm>
            <a:off x="1050888" y="7112000"/>
            <a:ext cx="10882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ctospor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147634" y="8267700"/>
            <a:ext cx="658336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wise whole genom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plot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fission yeast species created with YASS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itself. This figure was only made for a better understanding of the DNA based do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b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ignment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tospor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lignment of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yophil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lue lines represent sequences in the same orientation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 lines indicate inverted segments.</a:t>
            </a:r>
          </a:p>
        </p:txBody>
      </p:sp>
    </p:spTree>
    <p:extLst>
      <p:ext uri="{BB962C8B-B14F-4D97-AF65-F5344CB8AC3E}">
        <p14:creationId xmlns:p14="http://schemas.microsoft.com/office/powerpoint/2010/main" val="24960702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4.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23702" y="6951541"/>
            <a:ext cx="658336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evaluation of the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wise whole genome do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distribution of the pairwise whole genome alignmen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eated with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AS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≤-30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: sample size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e was no significant difference in the variance of the data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s depicting the size distributions of the inferred alignments in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 the concerning species pairs and their divergences from the expected exponential distributions. Bin =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distributions of the pairwise cases were not significantly differen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lmogorov-Smirnov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,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0156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o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0129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c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71452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o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j-Sc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Kép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55769"/>
            <a:ext cx="6858000" cy="3935996"/>
          </a:xfrm>
          <a:prstGeom prst="rect">
            <a:avLst/>
          </a:prstGeom>
        </p:spPr>
      </p:pic>
      <p:sp>
        <p:nvSpPr>
          <p:cNvPr id="9" name="Szövegdoboz 8"/>
          <p:cNvSpPr txBox="1"/>
          <p:nvPr/>
        </p:nvSpPr>
        <p:spPr>
          <a:xfrm>
            <a:off x="3075839" y="955769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E ≤ -30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Szövegdoboz 9"/>
          <p:cNvSpPr txBox="1"/>
          <p:nvPr/>
        </p:nvSpPr>
        <p:spPr>
          <a:xfrm>
            <a:off x="5192487" y="1232768"/>
            <a:ext cx="14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-Wallis test</a:t>
            </a:r>
          </a:p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=0.743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895621" y="4753265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N=4922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5211173" y="4753265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N=4504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3053397" y="4741629"/>
            <a:ext cx="724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N=4549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Kép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49041"/>
            <a:ext cx="2339109" cy="1319736"/>
          </a:xfrm>
          <a:prstGeom prst="rect">
            <a:avLst/>
          </a:prstGeom>
        </p:spPr>
      </p:pic>
      <p:sp>
        <p:nvSpPr>
          <p:cNvPr id="15" name="Szövegdoboz 14"/>
          <p:cNvSpPr txBox="1"/>
          <p:nvPr/>
        </p:nvSpPr>
        <p:spPr>
          <a:xfrm>
            <a:off x="978175" y="6521509"/>
            <a:ext cx="5597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Sj-Sp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Kép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5969" y="5249041"/>
            <a:ext cx="2359733" cy="1331372"/>
          </a:xfrm>
          <a:prstGeom prst="rect">
            <a:avLst/>
          </a:prstGeom>
        </p:spPr>
      </p:pic>
      <p:sp>
        <p:nvSpPr>
          <p:cNvPr id="17" name="Szövegdoboz 16"/>
          <p:cNvSpPr txBox="1"/>
          <p:nvPr/>
        </p:nvSpPr>
        <p:spPr>
          <a:xfrm>
            <a:off x="3127967" y="6521509"/>
            <a:ext cx="771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Sj-So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Kép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4999" y="5249041"/>
            <a:ext cx="2343001" cy="1321932"/>
          </a:xfrm>
          <a:prstGeom prst="rect">
            <a:avLst/>
          </a:prstGeom>
        </p:spPr>
      </p:pic>
      <p:sp>
        <p:nvSpPr>
          <p:cNvPr id="19" name="Szövegdoboz 18"/>
          <p:cNvSpPr txBox="1"/>
          <p:nvPr/>
        </p:nvSpPr>
        <p:spPr>
          <a:xfrm>
            <a:off x="5414164" y="6521509"/>
            <a:ext cx="771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Sj-Sc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-11115" y="94413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Szövegdoboz 20"/>
          <p:cNvSpPr txBox="1"/>
          <p:nvPr/>
        </p:nvSpPr>
        <p:spPr>
          <a:xfrm>
            <a:off x="4514999" y="509564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Szövegdoboz 21"/>
          <p:cNvSpPr txBox="1"/>
          <p:nvPr/>
        </p:nvSpPr>
        <p:spPr>
          <a:xfrm>
            <a:off x="-11115" y="509564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Szövegdoboz 22"/>
          <p:cNvSpPr txBox="1"/>
          <p:nvPr/>
        </p:nvSpPr>
        <p:spPr>
          <a:xfrm>
            <a:off x="2251942" y="50956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589102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5.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147634" y="8267700"/>
            <a:ext cx="65833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grams depicting the size distributions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equencie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foun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B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pecies and their divergences from the expected exponential distributions. Bin =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distributions of the pairwise cases were not significantly differen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ept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be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olmogorov-Smirnov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st,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23497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Kép 29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2887422"/>
            <a:ext cx="3429000" cy="1934657"/>
          </a:xfrm>
          <a:prstGeom prst="rect">
            <a:avLst/>
          </a:prstGeom>
        </p:spPr>
      </p:pic>
      <p:sp>
        <p:nvSpPr>
          <p:cNvPr id="31" name="Szövegdoboz 30"/>
          <p:cNvSpPr txBox="1"/>
          <p:nvPr/>
        </p:nvSpPr>
        <p:spPr>
          <a:xfrm>
            <a:off x="2252478" y="3059734"/>
            <a:ext cx="1249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ryophilus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Kép 31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429001" y="2887422"/>
            <a:ext cx="3429000" cy="1934657"/>
          </a:xfrm>
          <a:prstGeom prst="rect">
            <a:avLst/>
          </a:prstGeom>
        </p:spPr>
      </p:pic>
      <p:sp>
        <p:nvSpPr>
          <p:cNvPr id="33" name="Szövegdoboz 32"/>
          <p:cNvSpPr txBox="1"/>
          <p:nvPr/>
        </p:nvSpPr>
        <p:spPr>
          <a:xfrm>
            <a:off x="5670490" y="3059734"/>
            <a:ext cx="1249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ctosporus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Kép 33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3429001" y="816454"/>
            <a:ext cx="3429000" cy="1934658"/>
          </a:xfrm>
          <a:prstGeom prst="rect">
            <a:avLst/>
          </a:prstGeom>
        </p:spPr>
      </p:pic>
      <p:sp>
        <p:nvSpPr>
          <p:cNvPr id="35" name="Szövegdoboz 34"/>
          <p:cNvSpPr txBox="1"/>
          <p:nvPr/>
        </p:nvSpPr>
        <p:spPr>
          <a:xfrm>
            <a:off x="5910306" y="952764"/>
            <a:ext cx="1249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ombe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Kép 35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1" y="816454"/>
            <a:ext cx="3429000" cy="1934658"/>
          </a:xfrm>
          <a:prstGeom prst="rect">
            <a:avLst/>
          </a:prstGeom>
        </p:spPr>
      </p:pic>
      <p:sp>
        <p:nvSpPr>
          <p:cNvPr id="37" name="Szövegdoboz 36"/>
          <p:cNvSpPr txBox="1"/>
          <p:nvPr/>
        </p:nvSpPr>
        <p:spPr>
          <a:xfrm>
            <a:off x="2325092" y="952764"/>
            <a:ext cx="1103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en-GB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9" name="Táblázat 3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4249497"/>
              </p:ext>
            </p:extLst>
          </p:nvPr>
        </p:nvGraphicFramePr>
        <p:xfrm>
          <a:off x="1915317" y="5067068"/>
          <a:ext cx="3048000" cy="11296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52938627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24522680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49763279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39475445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373269800"/>
                    </a:ext>
                  </a:extLst>
                </a:gridCol>
              </a:tblGrid>
              <a:tr h="190500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Kolmogorov-</a:t>
                      </a:r>
                      <a:r>
                        <a:rPr lang="en-US" sz="1100" u="none" strike="noStrike" dirty="0" err="1">
                          <a:effectLst/>
                        </a:rPr>
                        <a:t>Smirno</a:t>
                      </a:r>
                      <a:r>
                        <a:rPr lang="hu-HU" sz="1100" u="none" strike="noStrike" dirty="0">
                          <a:effectLst/>
                        </a:rPr>
                        <a:t>v</a:t>
                      </a:r>
                      <a:r>
                        <a:rPr lang="en-US" sz="1100" u="none" strike="noStrike" dirty="0">
                          <a:effectLst/>
                        </a:rPr>
                        <a:t> test for equal distribution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138007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p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c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o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j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6090326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p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 dirty="0">
                          <a:effectLst/>
                        </a:rPr>
                        <a:t>0.14867</a:t>
                      </a:r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 dirty="0">
                          <a:effectLst/>
                        </a:rPr>
                        <a:t>0.18081</a:t>
                      </a:r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 dirty="0">
                          <a:effectLst/>
                        </a:rPr>
                        <a:t>0.023497</a:t>
                      </a:r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57165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c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>
                          <a:effectLst/>
                        </a:rPr>
                        <a:t>1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 dirty="0">
                          <a:effectLst/>
                        </a:rPr>
                        <a:t>0.30997</a:t>
                      </a:r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49399215"/>
                  </a:ext>
                </a:extLst>
              </a:tr>
              <a:tr h="154441"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o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u-HU" sz="1100" u="none" strike="noStrike" dirty="0">
                          <a:effectLst/>
                        </a:rPr>
                        <a:t>0.30997</a:t>
                      </a:r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1695313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hu-HU" sz="1100" u="none" strike="noStrike">
                          <a:effectLst/>
                        </a:rPr>
                        <a:t>Sj</a:t>
                      </a:r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hu-H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44088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47940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6.</a:t>
            </a:r>
          </a:p>
        </p:txBody>
      </p:sp>
      <p:sp>
        <p:nvSpPr>
          <p:cNvPr id="3" name="Szövegdoboz 2"/>
          <p:cNvSpPr txBox="1"/>
          <p:nvPr/>
        </p:nvSpPr>
        <p:spPr>
          <a:xfrm>
            <a:off x="133427" y="8982670"/>
            <a:ext cx="658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wise Mauve alignmen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distantly relat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phrinomycoti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using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GB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ponicus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reference genome. The LCB weight (minimal length of a LCB) was adjusted to 5000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s.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zövegdoboz 4"/>
          <p:cNvSpPr txBox="1"/>
          <p:nvPr/>
        </p:nvSpPr>
        <p:spPr>
          <a:xfrm>
            <a:off x="2991396" y="401646"/>
            <a:ext cx="9994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japonicu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Kép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706674"/>
            <a:ext cx="6720840" cy="1507544"/>
          </a:xfrm>
          <a:prstGeom prst="rect">
            <a:avLst/>
          </a:prstGeom>
        </p:spPr>
      </p:pic>
      <p:sp>
        <p:nvSpPr>
          <p:cNvPr id="9" name="Szövegdoboz 8"/>
          <p:cNvSpPr txBox="1"/>
          <p:nvPr/>
        </p:nvSpPr>
        <p:spPr>
          <a:xfrm>
            <a:off x="3136836" y="1967984"/>
            <a:ext cx="805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urina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Kép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283" y="2304618"/>
            <a:ext cx="6720840" cy="1507544"/>
          </a:xfrm>
          <a:prstGeom prst="rect">
            <a:avLst/>
          </a:prstGeom>
        </p:spPr>
      </p:pic>
      <p:sp>
        <p:nvSpPr>
          <p:cNvPr id="11" name="Szövegdoboz 10"/>
          <p:cNvSpPr txBox="1"/>
          <p:nvPr/>
        </p:nvSpPr>
        <p:spPr>
          <a:xfrm>
            <a:off x="2952003" y="3565928"/>
            <a:ext cx="108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omplicata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Kép 1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3902562"/>
            <a:ext cx="6720840" cy="1507544"/>
          </a:xfrm>
          <a:prstGeom prst="rect">
            <a:avLst/>
          </a:prstGeom>
        </p:spPr>
      </p:pic>
      <p:sp>
        <p:nvSpPr>
          <p:cNvPr id="13" name="Szövegdoboz 12"/>
          <p:cNvSpPr txBox="1"/>
          <p:nvPr/>
        </p:nvSpPr>
        <p:spPr>
          <a:xfrm>
            <a:off x="2963183" y="5169143"/>
            <a:ext cx="105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eforman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Kép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5560140"/>
            <a:ext cx="6720840" cy="1507544"/>
          </a:xfrm>
          <a:prstGeom prst="rect">
            <a:avLst/>
          </a:prstGeom>
        </p:spPr>
      </p:pic>
      <p:sp>
        <p:nvSpPr>
          <p:cNvPr id="15" name="Szövegdoboz 14"/>
          <p:cNvSpPr txBox="1"/>
          <p:nvPr/>
        </p:nvSpPr>
        <p:spPr>
          <a:xfrm>
            <a:off x="2869134" y="6821450"/>
            <a:ext cx="1330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actucaedebili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Kép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" y="7238167"/>
            <a:ext cx="6720840" cy="1507544"/>
          </a:xfrm>
          <a:prstGeom prst="rect">
            <a:avLst/>
          </a:prstGeom>
        </p:spPr>
      </p:pic>
      <p:sp>
        <p:nvSpPr>
          <p:cNvPr id="17" name="Szövegdoboz 16"/>
          <p:cNvSpPr txBox="1"/>
          <p:nvPr/>
        </p:nvSpPr>
        <p:spPr>
          <a:xfrm>
            <a:off x="2974564" y="8499477"/>
            <a:ext cx="1032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irregulari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37974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Kép 1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09" y="7196959"/>
            <a:ext cx="6720840" cy="1507544"/>
          </a:xfrm>
          <a:prstGeom prst="rect">
            <a:avLst/>
          </a:prstGeom>
        </p:spPr>
      </p:pic>
      <p:pic>
        <p:nvPicPr>
          <p:cNvPr id="18" name="Kép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09" y="5557846"/>
            <a:ext cx="6720840" cy="1507544"/>
          </a:xfrm>
          <a:prstGeom prst="rect">
            <a:avLst/>
          </a:prstGeom>
        </p:spPr>
      </p:pic>
      <p:pic>
        <p:nvPicPr>
          <p:cNvPr id="8" name="Kép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500" y="3918733"/>
            <a:ext cx="6720840" cy="1507544"/>
          </a:xfrm>
          <a:prstGeom prst="rect">
            <a:avLst/>
          </a:prstGeom>
        </p:spPr>
      </p:pic>
      <p:pic>
        <p:nvPicPr>
          <p:cNvPr id="6" name="Kép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09" y="2279620"/>
            <a:ext cx="6720840" cy="1507544"/>
          </a:xfrm>
          <a:prstGeom prst="rect">
            <a:avLst/>
          </a:prstGeom>
        </p:spPr>
      </p:pic>
      <p:pic>
        <p:nvPicPr>
          <p:cNvPr id="4" name="Kép 3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10" y="638449"/>
            <a:ext cx="6720840" cy="1507544"/>
          </a:xfrm>
          <a:prstGeom prst="rect">
            <a:avLst/>
          </a:prstGeom>
        </p:spPr>
      </p:pic>
      <p:sp>
        <p:nvSpPr>
          <p:cNvPr id="2" name="Szövegdoboz 1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7.</a:t>
            </a:r>
          </a:p>
        </p:txBody>
      </p:sp>
      <p:sp>
        <p:nvSpPr>
          <p:cNvPr id="3" name="Szövegdoboz 2"/>
          <p:cNvSpPr txBox="1"/>
          <p:nvPr/>
        </p:nvSpPr>
        <p:spPr>
          <a:xfrm>
            <a:off x="133427" y="8982670"/>
            <a:ext cx="658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wise Mauve alignment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distantly related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phrinomycoti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es using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hu-H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be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reference genome. The LCB weight (minimal length of a LCB) was adjusted to 5000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otides. 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zövegdoboz 4"/>
          <p:cNvSpPr txBox="1"/>
          <p:nvPr/>
        </p:nvSpPr>
        <p:spPr>
          <a:xfrm>
            <a:off x="2978697" y="401646"/>
            <a:ext cx="8250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ombe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3077568" y="1887901"/>
            <a:ext cx="805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murina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2939303" y="3565928"/>
            <a:ext cx="10842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S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omplicata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2950483" y="5169143"/>
            <a:ext cx="1054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deforman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Szövegdoboz 14"/>
          <p:cNvSpPr txBox="1"/>
          <p:nvPr/>
        </p:nvSpPr>
        <p:spPr>
          <a:xfrm>
            <a:off x="2856434" y="6821450"/>
            <a:ext cx="13303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actucaedebili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Szövegdoboz 16"/>
          <p:cNvSpPr txBox="1"/>
          <p:nvPr/>
        </p:nvSpPr>
        <p:spPr>
          <a:xfrm>
            <a:off x="2961864" y="8499477"/>
            <a:ext cx="1032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hu-HU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irregularis</a:t>
            </a:r>
            <a:endParaRPr lang="hu-HU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09938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2019300"/>
            <a:ext cx="6853149" cy="444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" name="Szövegdoboz 2"/>
          <p:cNvSpPr txBox="1"/>
          <p:nvPr/>
        </p:nvSpPr>
        <p:spPr>
          <a:xfrm>
            <a:off x="2288645" y="2019300"/>
            <a:ext cx="2272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Kruskal-Wallis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 test, </a:t>
            </a:r>
            <a:r>
              <a:rPr lang="hu-HU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 = 0.5562</a:t>
            </a:r>
          </a:p>
        </p:txBody>
      </p:sp>
      <p:sp>
        <p:nvSpPr>
          <p:cNvPr id="4" name="Szövegdoboz 3"/>
          <p:cNvSpPr txBox="1"/>
          <p:nvPr/>
        </p:nvSpPr>
        <p:spPr>
          <a:xfrm>
            <a:off x="0" y="0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hu-HU" b="1" dirty="0">
                <a:latin typeface="Arial" panose="020B0604020202020204" pitchFamily="34" charset="0"/>
                <a:cs typeface="Arial" panose="020B0604020202020204" pitchFamily="34" charset="0"/>
              </a:rPr>
              <a:t> S8.</a:t>
            </a:r>
          </a:p>
        </p:txBody>
      </p:sp>
      <p:sp>
        <p:nvSpPr>
          <p:cNvPr id="5" name="Szövegdoboz 4"/>
          <p:cNvSpPr txBox="1"/>
          <p:nvPr/>
        </p:nvSpPr>
        <p:spPr>
          <a:xfrm>
            <a:off x="133427" y="8614370"/>
            <a:ext cx="658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olutionary rates of proteins whose gene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ted at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B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t the NCBs (genomic regions that are outside of th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B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 chromosome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hu-H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mb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There is no significant difference among the samples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uskal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allis test, 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562).</a:t>
            </a:r>
          </a:p>
        </p:txBody>
      </p:sp>
    </p:spTree>
    <p:extLst>
      <p:ext uri="{BB962C8B-B14F-4D97-AF65-F5344CB8AC3E}">
        <p14:creationId xmlns:p14="http://schemas.microsoft.com/office/powerpoint/2010/main" val="22872775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0</TotalTime>
  <Words>798</Words>
  <Application>Microsoft Office PowerPoint</Application>
  <PresentationFormat>A4 Paper (210x297 mm)</PresentationFormat>
  <Paragraphs>8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-téma</vt:lpstr>
      <vt:lpstr>Supplementary figures  Genome comparisons of the fission yeasts reveal ancient collinear loci maintained by natural selec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  Genome comparisons of the fission yeasts reveal ancient collinear loci maintained by natural selection</dc:title>
  <dc:creator>Windows-felhasználó</dc:creator>
  <cp:lastModifiedBy>MDPI</cp:lastModifiedBy>
  <cp:revision>25</cp:revision>
  <dcterms:created xsi:type="dcterms:W3CDTF">2021-08-10T14:32:31Z</dcterms:created>
  <dcterms:modified xsi:type="dcterms:W3CDTF">2021-10-15T06:30:25Z</dcterms:modified>
</cp:coreProperties>
</file>